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7"/>
    <p:restoredTop sz="94648"/>
  </p:normalViewPr>
  <p:slideViewPr>
    <p:cSldViewPr snapToGrid="0">
      <p:cViewPr varScale="1">
        <p:scale>
          <a:sx n="117" d="100"/>
          <a:sy n="117" d="100"/>
        </p:scale>
        <p:origin x="20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5419890-5A82-B6B2-83D8-4FB497D52D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386D2441-ED43-41C0-EE54-5562C07204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04872EB-C456-5233-2B81-6123AF8715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E3631-4A0D-194D-9C53-9964C931030C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B452A0C-E3E0-E560-3E4D-078BEDFCF7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3EDF51E-28AC-491B-7B55-4C2F7C24E9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1FA27-910B-5442-9622-4B02D459EA4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8433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FEF79E5-A1C9-6BBB-66C8-C0F9815D2D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5062004-FD34-AEE9-2800-832661F2B8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ED6F78C-958A-5375-73D9-B3DBB452B5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E3631-4A0D-194D-9C53-9964C931030C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6C0E277-4239-2228-B439-1EBD88EAD5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19CDBD2-7DEB-39EF-1391-13D9843B6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1FA27-910B-5442-9622-4B02D459EA4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9379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3CEA4F90-79D7-B9C4-F7CD-BD96AAAC6F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EA8405A-E27F-5890-9CE2-E90CB5A201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4584A7B-053F-2C63-71F9-E65153B47F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E3631-4A0D-194D-9C53-9964C931030C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F126245-45E5-E361-54B8-5BAD26E5AF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A53EA74-F907-8AA6-84A2-F83C528469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1FA27-910B-5442-9622-4B02D459EA4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5276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790820F-A889-16E4-E458-E935E96C92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1859E24-97D5-E29B-EBA6-EB58D96181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0592F01-97BD-D930-DA36-A9FDA5B7C7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E3631-4A0D-194D-9C53-9964C931030C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99088DB-A81C-72F7-9F6C-B6390A7DC1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65A5272-592C-E7FD-FFCC-1CF91AD8C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1FA27-910B-5442-9622-4B02D459EA4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0709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2488F84-7165-7BB5-BD7F-8911674BEE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DB379BF-40A0-5665-E7D2-840DE037EC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C2905A6-F0ED-40EC-5EC1-FEB4069717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E3631-4A0D-194D-9C53-9964C931030C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AA9354E-EF55-6A05-5164-9DCEB61BC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57AE5E3-F03A-E236-350B-C90B37541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1FA27-910B-5442-9622-4B02D459EA4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7727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8B96D4F-7261-C608-2B82-3B69A21022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84CCB21-AA19-1B3E-B319-DB4C148252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FD0718B-135C-A140-85C8-372A8014AF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854EB1D-565B-1502-B8FA-D94EE1929C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E3631-4A0D-194D-9C53-9964C931030C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3189923-E7D6-4637-1D06-DBE8B9BD47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304F7E8-A72B-3579-407D-53179FC0A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1FA27-910B-5442-9622-4B02D459EA4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2680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CF4E831-C4F6-D0B5-DEED-E2B0F7EA48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75691C5-2B58-513D-CE2B-8BC1B184AD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4591022-44A0-019B-073A-F4BF4FD692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F69BC217-731E-BED6-4327-CE848FE2BD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5B41DDB0-ED0F-FD6A-4B08-0581697E80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EDD9059B-CBC3-D041-2FDE-A01496AF6E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E3631-4A0D-194D-9C53-9964C931030C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C1419A2B-69F0-E9E5-8070-8FECEA4F9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9E9B1D1D-DC6D-7CE3-EB81-864B0D87B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1FA27-910B-5442-9622-4B02D459EA4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6803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5D3D156-9A9A-648A-910A-A6F5B41FC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58EC84D2-0074-7179-752B-B2EE859DBC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E3631-4A0D-194D-9C53-9964C931030C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CE5468DE-1330-94B9-548B-4C8DD0575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E7B39D88-E6D2-D5CA-6F02-B6B6977A7E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1FA27-910B-5442-9622-4B02D459EA4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92485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BB77CD8D-24B1-E351-D526-C932EE282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E3631-4A0D-194D-9C53-9964C931030C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973B51E3-E9CA-6DC4-AE61-39F272A6CB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09C8A10C-F55A-DA98-E256-24BAA080AB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1FA27-910B-5442-9622-4B02D459EA4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5028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835CF31-C17A-75CD-8755-75F7C78442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C674D98-4038-CD13-B469-00E1C7BEA3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1D7D169-C3B7-5BE1-A33A-8194352F28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B22549C-8E30-B4B8-515B-69F43BB7FE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E3631-4A0D-194D-9C53-9964C931030C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A090DC2-12AF-DD2B-7CBC-60739F8AE5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5DF025A-9766-33F5-F251-4FB912A87C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1FA27-910B-5442-9622-4B02D459EA4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9238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D750DF-41E3-6DD5-9F20-F013D79E10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F90AF75F-A767-88DA-479F-AC83FA19DE3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D2D6E2C-AC00-98DC-28EB-41C7879C1F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572D104-3BBE-5618-833F-9092A3E7A6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E3631-4A0D-194D-9C53-9964C931030C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928A727-BCB7-8FC7-ED4A-F030FF0B5B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F613161-490C-4205-DBBE-91018B374B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1FA27-910B-5442-9622-4B02D459EA4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7933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3B85CC76-4C41-BA53-3714-B726A7E67F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6B9A893-908D-DD31-59EA-E7F2521595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7AC7383-E148-04B2-5D43-41B511A372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AE3631-4A0D-194D-9C53-9964C931030C}" type="datetimeFigureOut">
              <a:rPr lang="de-DE" smtClean="0"/>
              <a:t>26.02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C4D86AD-1B2D-71BF-FA61-98A37C5AA5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0C546E8-6D4B-420B-36BB-657B32DADD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11FA27-910B-5442-9622-4B02D459EA4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7633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 descr="Ein Bild, das Karte enthält.&#10;&#10;Automatisch generierte Beschreibung">
            <a:extLst>
              <a:ext uri="{FF2B5EF4-FFF2-40B4-BE49-F238E27FC236}">
                <a16:creationId xmlns:a16="http://schemas.microsoft.com/office/drawing/2014/main" id="{792DD676-5F96-4D34-DF15-E162BCB2602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0125"/>
          <a:stretch/>
        </p:blipFill>
        <p:spPr>
          <a:xfrm>
            <a:off x="339325" y="380306"/>
            <a:ext cx="4105084" cy="3064833"/>
          </a:xfrm>
          <a:prstGeom prst="rect">
            <a:avLst/>
          </a:prstGeom>
        </p:spPr>
      </p:pic>
      <p:pic>
        <p:nvPicPr>
          <p:cNvPr id="7" name="Grafik 6" descr="Ein Bild, das Zeichnung, Text, Karte enthält.&#10;&#10;Automatisch generierte Beschreibung">
            <a:extLst>
              <a:ext uri="{FF2B5EF4-FFF2-40B4-BE49-F238E27FC236}">
                <a16:creationId xmlns:a16="http://schemas.microsoft.com/office/drawing/2014/main" id="{D59DEFF6-057E-B0B7-B052-87F65EA711C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9452"/>
          <a:stretch/>
        </p:blipFill>
        <p:spPr>
          <a:xfrm>
            <a:off x="339325" y="3572341"/>
            <a:ext cx="4105084" cy="3283987"/>
          </a:xfrm>
          <a:prstGeom prst="rect">
            <a:avLst/>
          </a:prstGeom>
        </p:spPr>
      </p:pic>
      <p:sp>
        <p:nvSpPr>
          <p:cNvPr id="13" name="Textfeld 12">
            <a:extLst>
              <a:ext uri="{FF2B5EF4-FFF2-40B4-BE49-F238E27FC236}">
                <a16:creationId xmlns:a16="http://schemas.microsoft.com/office/drawing/2014/main" id="{8102FC99-2649-3790-DA70-309AA0EFE90D}"/>
              </a:ext>
            </a:extLst>
          </p:cNvPr>
          <p:cNvSpPr txBox="1"/>
          <p:nvPr/>
        </p:nvSpPr>
        <p:spPr>
          <a:xfrm>
            <a:off x="339325" y="240958"/>
            <a:ext cx="70807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Figure 7: </a:t>
            </a:r>
            <a:r>
              <a:rPr lang="de-DE" sz="1400" dirty="0" err="1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Eosinophilic</a:t>
            </a:r>
            <a:r>
              <a:rPr lang="de-DE" sz="14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granulocytes</a:t>
            </a:r>
            <a:r>
              <a:rPr lang="de-DE" sz="14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tain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ongo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KAIA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®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977C8913-8091-409C-7DD2-3C57E6FD76D8}"/>
              </a:ext>
            </a:extLst>
          </p:cNvPr>
          <p:cNvSpPr txBox="1"/>
          <p:nvPr/>
        </p:nvSpPr>
        <p:spPr>
          <a:xfrm>
            <a:off x="339325" y="645160"/>
            <a:ext cx="3071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b="1" dirty="0"/>
              <a:t>a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640F00DF-A4B1-7AF6-C88C-46D6AEC80DE3}"/>
              </a:ext>
            </a:extLst>
          </p:cNvPr>
          <p:cNvSpPr txBox="1"/>
          <p:nvPr/>
        </p:nvSpPr>
        <p:spPr>
          <a:xfrm>
            <a:off x="6525040" y="2403053"/>
            <a:ext cx="3071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b="1" dirty="0"/>
              <a:t>c</a:t>
            </a:r>
            <a:endParaRPr lang="de-DE" sz="1800" b="1" dirty="0"/>
          </a:p>
        </p:txBody>
      </p:sp>
      <p:pic>
        <p:nvPicPr>
          <p:cNvPr id="9" name="Grafik 8" descr="Ein Bild, das Karte, Text, Atlas enthält.&#10;&#10;Automatisch generierte Beschreibung">
            <a:extLst>
              <a:ext uri="{FF2B5EF4-FFF2-40B4-BE49-F238E27FC236}">
                <a16:creationId xmlns:a16="http://schemas.microsoft.com/office/drawing/2014/main" id="{7C7053F8-514B-9142-6A73-3A9FB083509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16704" y="2403052"/>
            <a:ext cx="4503926" cy="2338577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9BE4BFF0-54F0-8244-CEA5-9349E91E2A85}"/>
              </a:ext>
            </a:extLst>
          </p:cNvPr>
          <p:cNvSpPr txBox="1"/>
          <p:nvPr/>
        </p:nvSpPr>
        <p:spPr>
          <a:xfrm>
            <a:off x="5916704" y="4864897"/>
            <a:ext cx="4573656" cy="11541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lphaLcPeriod"/>
            </a:pPr>
            <a:r>
              <a:rPr lang="de-DE" sz="1100" dirty="0" err="1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Eosinophilic</a:t>
            </a:r>
            <a:r>
              <a:rPr lang="de-DE" sz="11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granulocytes</a:t>
            </a:r>
            <a:r>
              <a:rPr lang="de-DE" sz="11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tain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ng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342900" indent="-342900">
              <a:buAutoNum type="alphaLcPeriod"/>
            </a:pP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IKAIA</a:t>
            </a:r>
            <a:r>
              <a:rPr lang="en-US" sz="1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®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gree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ute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lin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quamou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pithelium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as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ircl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urpl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hotspo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iamete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200µm)</a:t>
            </a:r>
          </a:p>
          <a:p>
            <a:pPr marL="342900" indent="-342900">
              <a:buAutoNum type="alphaLcPeriod"/>
            </a:pPr>
            <a:r>
              <a:rPr lang="de-DE" sz="1100">
                <a:latin typeface="Arial" panose="020B0604020202020204" pitchFamily="34" charset="0"/>
                <a:cs typeface="Arial" panose="020B0604020202020204" pitchFamily="34" charset="0"/>
              </a:rPr>
              <a:t>Enlarg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b)</a:t>
            </a:r>
          </a:p>
          <a:p>
            <a:endParaRPr lang="de-DE" sz="1400" dirty="0"/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A9C45EEB-3F93-DDF9-EAD2-0F3D8FB61B76}"/>
              </a:ext>
            </a:extLst>
          </p:cNvPr>
          <p:cNvSpPr txBox="1"/>
          <p:nvPr/>
        </p:nvSpPr>
        <p:spPr>
          <a:xfrm>
            <a:off x="339325" y="3572341"/>
            <a:ext cx="3071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b="1" dirty="0"/>
              <a:t>b</a:t>
            </a:r>
            <a:endParaRPr lang="de-DE" sz="1800" b="1" dirty="0"/>
          </a:p>
        </p:txBody>
      </p:sp>
      <p:sp>
        <p:nvSpPr>
          <p:cNvPr id="2" name="Rechteck 1">
            <a:extLst>
              <a:ext uri="{FF2B5EF4-FFF2-40B4-BE49-F238E27FC236}">
                <a16:creationId xmlns:a16="http://schemas.microsoft.com/office/drawing/2014/main" id="{C24AAAB0-6DAC-4D17-C294-89FE8FC4AD83}"/>
              </a:ext>
            </a:extLst>
          </p:cNvPr>
          <p:cNvSpPr/>
          <p:nvPr/>
        </p:nvSpPr>
        <p:spPr>
          <a:xfrm>
            <a:off x="2296392" y="5881255"/>
            <a:ext cx="1714500" cy="847872"/>
          </a:xfrm>
          <a:prstGeom prst="rect">
            <a:avLst/>
          </a:prstGeom>
          <a:noFill/>
          <a:ln w="158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4" name="Gerade Verbindung mit Pfeil 3">
            <a:extLst>
              <a:ext uri="{FF2B5EF4-FFF2-40B4-BE49-F238E27FC236}">
                <a16:creationId xmlns:a16="http://schemas.microsoft.com/office/drawing/2014/main" id="{BBF84AA7-6463-D099-2485-DFE05CCB539F}"/>
              </a:ext>
            </a:extLst>
          </p:cNvPr>
          <p:cNvCxnSpPr/>
          <p:nvPr/>
        </p:nvCxnSpPr>
        <p:spPr>
          <a:xfrm flipV="1">
            <a:off x="4021282" y="4405745"/>
            <a:ext cx="1895422" cy="19302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Textfeld 5">
            <a:extLst>
              <a:ext uri="{FF2B5EF4-FFF2-40B4-BE49-F238E27FC236}">
                <a16:creationId xmlns:a16="http://schemas.microsoft.com/office/drawing/2014/main" id="{0882911D-B3CE-A7C6-3DDA-48F757C504F0}"/>
              </a:ext>
            </a:extLst>
          </p:cNvPr>
          <p:cNvSpPr txBox="1"/>
          <p:nvPr/>
        </p:nvSpPr>
        <p:spPr>
          <a:xfrm>
            <a:off x="269595" y="3245528"/>
            <a:ext cx="917760" cy="1834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1CBB2157-3DE9-6BA8-5893-BFB36014DB67}"/>
              </a:ext>
            </a:extLst>
          </p:cNvPr>
          <p:cNvSpPr txBox="1"/>
          <p:nvPr/>
        </p:nvSpPr>
        <p:spPr>
          <a:xfrm>
            <a:off x="269595" y="6617042"/>
            <a:ext cx="917760" cy="1834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C6678D4D-E4C1-87E5-C532-42238D864DFE}"/>
              </a:ext>
            </a:extLst>
          </p:cNvPr>
          <p:cNvSpPr txBox="1"/>
          <p:nvPr/>
        </p:nvSpPr>
        <p:spPr>
          <a:xfrm>
            <a:off x="5914462" y="4573966"/>
            <a:ext cx="917760" cy="1834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6462650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</Words>
  <Application>Microsoft Macintosh PowerPoint</Application>
  <PresentationFormat>Breitbild</PresentationFormat>
  <Paragraphs>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ironimus, Theresa</dc:creator>
  <cp:lastModifiedBy>Hironimus, Theresa</cp:lastModifiedBy>
  <cp:revision>6</cp:revision>
  <dcterms:created xsi:type="dcterms:W3CDTF">2024-09-02T17:13:12Z</dcterms:created>
  <dcterms:modified xsi:type="dcterms:W3CDTF">2025-02-26T18:57:49Z</dcterms:modified>
</cp:coreProperties>
</file>